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E6400-5587-4421-9574-2C76B0FC83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D3ECC-2BD1-4B5C-B79C-7962737CEE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8306A-0AA8-45F8-837C-63FD7A900E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383CE-3A2F-465C-BEAE-EF6B3C643C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06C53-66D0-4016-A7C6-5DEB83CAD7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503E2-AEC9-4803-B5E3-5A2AA97037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E15C5C-34C6-4B8D-9BBC-016239CEF2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AB932B-A9F8-40F3-AED9-DC42823DCB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6EF30-C5E8-452E-A9FC-8B146A31DC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C629C-F449-410A-ABED-FF53B9F990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355D8-7770-482A-8D66-3883B67A19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3907C-68A2-400C-9851-EB2734CE13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A0BC13-5DCD-4958-B39B-187FDB34CF7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80880" y="2286000"/>
          <a:ext cx="8534520" cy="1370160"/>
        </p:xfrm>
        <a:graphic>
          <a:graphicData uri="http://schemas.openxmlformats.org/drawingml/2006/table">
            <a:tbl>
              <a:tblPr/>
              <a:tblGrid>
                <a:gridCol w="1514520"/>
                <a:gridCol w="1017720"/>
                <a:gridCol w="1015920"/>
                <a:gridCol w="1066680"/>
                <a:gridCol w="1144800"/>
                <a:gridCol w="923760"/>
                <a:gridCol w="925560"/>
                <a:gridCol w="925560"/>
              </a:tblGrid>
              <a:tr h="34776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Vill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pu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Sera T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Positive Ser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sitive rate 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b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c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45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66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Hyeonna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,5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.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12"/>
          <p:cNvSpPr/>
          <p:nvPr/>
        </p:nvSpPr>
        <p:spPr>
          <a:xfrm>
            <a:off x="457200" y="1752480"/>
            <a:ext cx="6858000" cy="41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6. Positive rate of fluorescent antibody responses of sera in Goseong surveyed are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4"/>
          <p:cNvSpPr/>
          <p:nvPr/>
        </p:nvSpPr>
        <p:spPr>
          <a:xfrm>
            <a:off x="1143000" y="3809880"/>
            <a:ext cx="670572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Note.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IFAT; Indirect fluorescent antibody tes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API; Annual antibody positive index determined by IF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 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PI; Annual parasite index of 2005 and 20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8T01:59:49Z</dcterms:created>
  <dc:creator>Lee</dc:creator>
  <dc:description/>
  <dc:language>en-US</dc:language>
  <cp:lastModifiedBy>Marcel Hommel</cp:lastModifiedBy>
  <dcterms:modified xsi:type="dcterms:W3CDTF">2012-07-22T10:31:10Z</dcterms:modified>
  <cp:revision>3</cp:revision>
  <dc:subject/>
  <dc:title>Slide 1</dc:title>
</cp:coreProperties>
</file>